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60" r:id="rId4"/>
    <p:sldId id="261" r:id="rId5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7" autoAdjust="0"/>
    <p:restoredTop sz="94660"/>
  </p:normalViewPr>
  <p:slideViewPr>
    <p:cSldViewPr snapToGrid="0">
      <p:cViewPr varScale="1">
        <p:scale>
          <a:sx n="88" d="100"/>
          <a:sy n="88" d="100"/>
        </p:scale>
        <p:origin x="485" y="3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260AB09-97E9-D890-06C5-73DD64B8402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F38C4F36-3B87-52AE-3BEA-5BC92B072CE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666866A-3D4C-2652-BBDE-2E9E90263D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0B136-D3AB-45DC-A0A8-09ADBAB492E4}" type="datetimeFigureOut">
              <a:rPr lang="de-DE" smtClean="0"/>
              <a:t>24.03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3F346BB-89C1-6010-305E-B1F4E7654D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BD06E86-E295-69FF-C736-8D67FB1524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13EF2-75AB-404C-B36A-A8F1968E66D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422644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D4AE792-B69A-6A5E-D539-33EB4AAC3F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73B84787-654B-F4FC-4437-C4502199CF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CD9787E-D174-7D9A-8802-9C89D3AF78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0B136-D3AB-45DC-A0A8-09ADBAB492E4}" type="datetimeFigureOut">
              <a:rPr lang="de-DE" smtClean="0"/>
              <a:t>24.03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F333293-1D92-DC22-C962-857F98C662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791C26D-F9AB-613F-4D88-EBBC47CA45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13EF2-75AB-404C-B36A-A8F1968E66D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874896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664337BC-C934-E900-317F-8C2EFBACFC3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5736DA5D-E9AE-BBAD-3955-92E819A2F23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7ABFBFA-8C52-6863-7B9C-0CCAA2D550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0B136-D3AB-45DC-A0A8-09ADBAB492E4}" type="datetimeFigureOut">
              <a:rPr lang="de-DE" smtClean="0"/>
              <a:t>24.03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CD58639-5F38-9695-94E3-F81D121FD2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BA85A53-8F74-0770-C50E-8B89BE42D0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13EF2-75AB-404C-B36A-A8F1968E66D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449757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D0AFF92-B61B-4AA0-61BC-6B5C5DA736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98D3A7A1-867F-4ECC-D221-5C074045C54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27C700D-C971-14A4-AFC7-D36FA1DB5A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0B136-D3AB-45DC-A0A8-09ADBAB492E4}" type="datetimeFigureOut">
              <a:rPr lang="de-DE" smtClean="0"/>
              <a:t>24.03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14086E0F-29C3-41F8-704C-4F5DA4197B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FBE9D96-D16F-3CF9-C112-F19FB3EE5A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13EF2-75AB-404C-B36A-A8F1968E66D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90599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86B5BFB-6957-E658-AC78-3A752EE1F3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C57EF9CB-8FDC-CB1D-6A4E-A554424125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7DFA3368-A02A-E155-7CEB-4E99A09BC8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0B136-D3AB-45DC-A0A8-09ADBAB492E4}" type="datetimeFigureOut">
              <a:rPr lang="de-DE" smtClean="0"/>
              <a:t>24.03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32D0D28C-F0C4-3584-FB6C-30A721E523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4219EB2-0C20-A07F-B812-183CC829C2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13EF2-75AB-404C-B36A-A8F1968E66D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90041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4531601-F1A6-6EE9-7B17-104A700928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D326C8F9-A934-DA6B-D6A1-D0E92722438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97B04C94-36F6-38ED-E05F-225221A83F8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F5267A6D-FB83-1B5B-2BB3-AC32244D4D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0B136-D3AB-45DC-A0A8-09ADBAB492E4}" type="datetimeFigureOut">
              <a:rPr lang="de-DE" smtClean="0"/>
              <a:t>24.03.20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4E396012-6442-D466-52E3-FF60E7CA6A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F78B9CE4-95CC-B3C8-E42B-5217D085BB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13EF2-75AB-404C-B36A-A8F1968E66D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445480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6EB1182-6DEE-3207-BAB8-9D86FC0A12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4638F9ED-DDF8-041F-DF26-AE6F07CD24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916D475B-4263-7ED9-810C-53FDCCCD5BF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52AF7C33-5D5C-70D4-0717-6C6E45F391D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FC6259B1-DD71-07A6-2A27-08813F99AC5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5CF2A0A0-AE8F-BB14-DAA8-BB1CB88E35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0B136-D3AB-45DC-A0A8-09ADBAB492E4}" type="datetimeFigureOut">
              <a:rPr lang="de-DE" smtClean="0"/>
              <a:t>24.03.2024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3D231195-1DDA-C55E-3050-4C964289BA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A7524AD1-9A10-9157-4654-FC12ADA55B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13EF2-75AB-404C-B36A-A8F1968E66D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631779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A421920-6FA3-543D-9CD4-05FC4E7FE7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0D8CEC00-5876-4470-BE21-FFF7935550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0B136-D3AB-45DC-A0A8-09ADBAB492E4}" type="datetimeFigureOut">
              <a:rPr lang="de-DE" smtClean="0"/>
              <a:t>24.03.2024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69FFEDCA-336E-028B-BF35-6F4E1CA515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16D2AF92-98C0-A476-E49E-2A542F63F7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13EF2-75AB-404C-B36A-A8F1968E66D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173687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1BE1A56F-3C77-FE3A-616E-B731E676B9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0B136-D3AB-45DC-A0A8-09ADBAB492E4}" type="datetimeFigureOut">
              <a:rPr lang="de-DE" smtClean="0"/>
              <a:t>24.03.2024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E5D5BBC0-02D4-C388-04B8-08F9A74795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2F2B2A75-54A2-A18E-D8A6-FF562AF6DB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13EF2-75AB-404C-B36A-A8F1968E66D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18912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29F6F01-9C5D-9AE9-5875-D58CB8189B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363A6D6F-E968-D84E-4B6B-6BEF410EACA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6E2F30AA-F2E5-6DF3-94E7-01D136EA4F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6B54EC2D-D25B-21B5-6BBD-71BEF52A54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0B136-D3AB-45DC-A0A8-09ADBAB492E4}" type="datetimeFigureOut">
              <a:rPr lang="de-DE" smtClean="0"/>
              <a:t>24.03.20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6799A033-0062-BB81-8B03-5BD736B301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19ECFD82-2442-C6F4-0C25-1C9653C13F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13EF2-75AB-404C-B36A-A8F1968E66D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665674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E00759C-8774-128B-834E-F7E2FB043A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3E42F785-404B-D217-B104-B95E8C56704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A39D6D4D-E803-68C7-DC22-F7D1C4D1D8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160C5A9B-EA97-EA82-D7DA-66D68E6DF4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60B136-D3AB-45DC-A0A8-09ADBAB492E4}" type="datetimeFigureOut">
              <a:rPr lang="de-DE" smtClean="0"/>
              <a:t>24.03.2024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62814704-172F-7BFA-8180-FE13B57A49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28BF7A94-1FB6-405E-AF44-B823225E95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C13EF2-75AB-404C-B36A-A8F1968E66D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927162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DDD80A37-B45A-BCD7-DFDC-E736E97F01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20779185-EC63-D96F-A671-8073246844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A19CE30-0485-34AF-9CAE-6BA710D9ABC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60B136-D3AB-45DC-A0A8-09ADBAB492E4}" type="datetimeFigureOut">
              <a:rPr lang="de-DE" smtClean="0"/>
              <a:t>24.03.2024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C57BF57-0114-18C2-E084-09275630B6F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AF570F87-C769-5061-65DC-7FEBD13E358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C13EF2-75AB-404C-B36A-A8F1968E66D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364659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oleObject" Target="../embeddings/oleObject3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emf"/><Relationship Id="rId4" Type="http://schemas.openxmlformats.org/officeDocument/2006/relationships/oleObject" Target="../embeddings/oleObject4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oleObject" Target="../embeddings/oleObject5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emf"/><Relationship Id="rId4" Type="http://schemas.openxmlformats.org/officeDocument/2006/relationships/oleObject" Target="../embeddings/oleObject6.bin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oleObject" Target="../embeddings/oleObject7.bin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emf"/><Relationship Id="rId4" Type="http://schemas.openxmlformats.org/officeDocument/2006/relationships/oleObject" Target="../embeddings/oleObject8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kt 1">
            <a:extLst>
              <a:ext uri="{FF2B5EF4-FFF2-40B4-BE49-F238E27FC236}">
                <a16:creationId xmlns:a16="http://schemas.microsoft.com/office/drawing/2014/main" id="{76A449C7-3722-44BC-9E5A-BA00F218BD39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64802" y="459735"/>
          <a:ext cx="9282112" cy="3430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9281421" imgH="3430074" progId="Prism10.Document">
                  <p:embed/>
                </p:oleObj>
              </mc:Choice>
              <mc:Fallback>
                <p:oleObj name="Prism 10" r:id="rId2" imgW="9281421" imgH="3430074" progId="Prism10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76A449C7-3722-44BC-9E5A-BA00F218BD3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64802" y="459735"/>
                        <a:ext cx="9282112" cy="34305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kt 2">
            <a:extLst>
              <a:ext uri="{FF2B5EF4-FFF2-40B4-BE49-F238E27FC236}">
                <a16:creationId xmlns:a16="http://schemas.microsoft.com/office/drawing/2014/main" id="{E3C857A9-AC40-D373-8C20-2DF439547977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13184" y="3730670"/>
          <a:ext cx="9301162" cy="2838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9301219" imgH="2839017" progId="Prism10.Document">
                  <p:embed/>
                </p:oleObj>
              </mc:Choice>
              <mc:Fallback>
                <p:oleObj name="Prism 10" r:id="rId4" imgW="9301219" imgH="2839017" progId="Prism10.Document">
                  <p:embed/>
                  <p:pic>
                    <p:nvPicPr>
                      <p:cNvPr id="3" name="Objekt 2">
                        <a:extLst>
                          <a:ext uri="{FF2B5EF4-FFF2-40B4-BE49-F238E27FC236}">
                            <a16:creationId xmlns:a16="http://schemas.microsoft.com/office/drawing/2014/main" id="{E3C857A9-AC40-D373-8C20-2DF43954797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13184" y="3730670"/>
                        <a:ext cx="9301162" cy="2838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feld 3">
            <a:extLst>
              <a:ext uri="{FF2B5EF4-FFF2-40B4-BE49-F238E27FC236}">
                <a16:creationId xmlns:a16="http://schemas.microsoft.com/office/drawing/2014/main" id="{8E2B2DA6-931C-D5A6-9EE6-BCEF55D7E988}"/>
              </a:ext>
            </a:extLst>
          </p:cNvPr>
          <p:cNvSpPr txBox="1"/>
          <p:nvPr/>
        </p:nvSpPr>
        <p:spPr>
          <a:xfrm>
            <a:off x="24215" y="19853"/>
            <a:ext cx="24283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err="1"/>
              <a:t>Supplemental</a:t>
            </a:r>
            <a:r>
              <a:rPr lang="de-DE" b="1" dirty="0"/>
              <a:t> Figure S3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85623382-8A04-B7C1-30BE-101C68D54204}"/>
              </a:ext>
            </a:extLst>
          </p:cNvPr>
          <p:cNvSpPr txBox="1"/>
          <p:nvPr/>
        </p:nvSpPr>
        <p:spPr>
          <a:xfrm>
            <a:off x="58082" y="42789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B3E0ABAF-A704-F14A-CCD7-B72F3760BF40}"/>
              </a:ext>
            </a:extLst>
          </p:cNvPr>
          <p:cNvSpPr txBox="1"/>
          <p:nvPr/>
        </p:nvSpPr>
        <p:spPr>
          <a:xfrm>
            <a:off x="56756" y="3816780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8797999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kt 1">
            <a:extLst>
              <a:ext uri="{FF2B5EF4-FFF2-40B4-BE49-F238E27FC236}">
                <a16:creationId xmlns:a16="http://schemas.microsoft.com/office/drawing/2014/main" id="{BBC85A2A-6110-BC3E-6462-82141A879E84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91584" y="187552"/>
          <a:ext cx="9310688" cy="34194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9310578" imgH="3419635" progId="Prism10.Document">
                  <p:embed/>
                </p:oleObj>
              </mc:Choice>
              <mc:Fallback>
                <p:oleObj name="Prism 10" r:id="rId2" imgW="9310578" imgH="3419635" progId="Prism10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BBC85A2A-6110-BC3E-6462-82141A879E8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91584" y="187552"/>
                        <a:ext cx="9310688" cy="34194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kt 2">
            <a:extLst>
              <a:ext uri="{FF2B5EF4-FFF2-40B4-BE49-F238E27FC236}">
                <a16:creationId xmlns:a16="http://schemas.microsoft.com/office/drawing/2014/main" id="{6FE9DAE5-97B8-9C59-93EF-B5F073568E3D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99522" y="3351590"/>
          <a:ext cx="9302750" cy="3355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9303019" imgH="3355562" progId="Prism10.Document">
                  <p:embed/>
                </p:oleObj>
              </mc:Choice>
              <mc:Fallback>
                <p:oleObj name="Prism 10" r:id="rId4" imgW="9303019" imgH="3355562" progId="Prism10.Document">
                  <p:embed/>
                  <p:pic>
                    <p:nvPicPr>
                      <p:cNvPr id="3" name="Objekt 2">
                        <a:extLst>
                          <a:ext uri="{FF2B5EF4-FFF2-40B4-BE49-F238E27FC236}">
                            <a16:creationId xmlns:a16="http://schemas.microsoft.com/office/drawing/2014/main" id="{6FE9DAE5-97B8-9C59-93EF-B5F073568E3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99522" y="3351590"/>
                        <a:ext cx="9302750" cy="3355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feld 3">
            <a:extLst>
              <a:ext uri="{FF2B5EF4-FFF2-40B4-BE49-F238E27FC236}">
                <a16:creationId xmlns:a16="http://schemas.microsoft.com/office/drawing/2014/main" id="{AA0A12EB-5AA0-3AA6-8EC0-89A8A421186C}"/>
              </a:ext>
            </a:extLst>
          </p:cNvPr>
          <p:cNvSpPr txBox="1"/>
          <p:nvPr/>
        </p:nvSpPr>
        <p:spPr>
          <a:xfrm>
            <a:off x="58082" y="427890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cs typeface="Arial" panose="020B0604020202020204" pitchFamily="34" charset="0"/>
              </a:rPr>
              <a:t>C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F389B10E-9632-13B6-9C9F-2D33EB0B631E}"/>
              </a:ext>
            </a:extLst>
          </p:cNvPr>
          <p:cNvSpPr txBox="1"/>
          <p:nvPr/>
        </p:nvSpPr>
        <p:spPr>
          <a:xfrm>
            <a:off x="58886" y="3426756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cs typeface="Arial" panose="020B0604020202020204" pitchFamily="34" charset="0"/>
              </a:rPr>
              <a:t>D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77A60766-0D63-29ED-ED74-B7A2513ACF66}"/>
              </a:ext>
            </a:extLst>
          </p:cNvPr>
          <p:cNvSpPr txBox="1"/>
          <p:nvPr/>
        </p:nvSpPr>
        <p:spPr>
          <a:xfrm>
            <a:off x="24215" y="19853"/>
            <a:ext cx="24283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err="1"/>
              <a:t>Supplemental</a:t>
            </a:r>
            <a:r>
              <a:rPr lang="de-DE" b="1" dirty="0"/>
              <a:t> Figure S3</a:t>
            </a:r>
          </a:p>
        </p:txBody>
      </p:sp>
    </p:spTree>
    <p:extLst>
      <p:ext uri="{BB962C8B-B14F-4D97-AF65-F5344CB8AC3E}">
        <p14:creationId xmlns:p14="http://schemas.microsoft.com/office/powerpoint/2010/main" val="34155541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kt 1">
            <a:extLst>
              <a:ext uri="{FF2B5EF4-FFF2-40B4-BE49-F238E27FC236}">
                <a16:creationId xmlns:a16="http://schemas.microsoft.com/office/drawing/2014/main" id="{22827D84-CD0E-441D-E9DC-49B9CEFD2124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27265" y="221343"/>
          <a:ext cx="9334500" cy="3352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9334694" imgH="3352323" progId="Prism10.Document">
                  <p:embed/>
                </p:oleObj>
              </mc:Choice>
              <mc:Fallback>
                <p:oleObj name="Prism 10" r:id="rId2" imgW="9334694" imgH="3352323" progId="Prism10.Document">
                  <p:embed/>
                  <p:pic>
                    <p:nvPicPr>
                      <p:cNvPr id="2" name="Objekt 1">
                        <a:extLst>
                          <a:ext uri="{FF2B5EF4-FFF2-40B4-BE49-F238E27FC236}">
                            <a16:creationId xmlns:a16="http://schemas.microsoft.com/office/drawing/2014/main" id="{22827D84-CD0E-441D-E9DC-49B9CEFD212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27265" y="221343"/>
                        <a:ext cx="9334500" cy="33528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kt 2">
            <a:extLst>
              <a:ext uri="{FF2B5EF4-FFF2-40B4-BE49-F238E27FC236}">
                <a16:creationId xmlns:a16="http://schemas.microsoft.com/office/drawing/2014/main" id="{E7D50C4A-700E-E246-7438-CF212E63961D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27265" y="3429000"/>
          <a:ext cx="9288462" cy="32845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9288980" imgH="3283930" progId="Prism10.Document">
                  <p:embed/>
                </p:oleObj>
              </mc:Choice>
              <mc:Fallback>
                <p:oleObj name="Prism 10" r:id="rId4" imgW="9288980" imgH="3283930" progId="Prism10.Document">
                  <p:embed/>
                  <p:pic>
                    <p:nvPicPr>
                      <p:cNvPr id="3" name="Objekt 2">
                        <a:extLst>
                          <a:ext uri="{FF2B5EF4-FFF2-40B4-BE49-F238E27FC236}">
                            <a16:creationId xmlns:a16="http://schemas.microsoft.com/office/drawing/2014/main" id="{E7D50C4A-700E-E246-7438-CF212E63961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27265" y="3429000"/>
                        <a:ext cx="9288462" cy="32845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feld 3">
            <a:extLst>
              <a:ext uri="{FF2B5EF4-FFF2-40B4-BE49-F238E27FC236}">
                <a16:creationId xmlns:a16="http://schemas.microsoft.com/office/drawing/2014/main" id="{93C96563-BD97-6C32-EBD1-E982AE2AD171}"/>
              </a:ext>
            </a:extLst>
          </p:cNvPr>
          <p:cNvSpPr txBox="1"/>
          <p:nvPr/>
        </p:nvSpPr>
        <p:spPr>
          <a:xfrm>
            <a:off x="58886" y="427890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cs typeface="Arial" panose="020B0604020202020204" pitchFamily="34" charset="0"/>
              </a:rPr>
              <a:t>E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2402BBC7-69FB-DCE6-F480-1B36D21FDDEA}"/>
              </a:ext>
            </a:extLst>
          </p:cNvPr>
          <p:cNvSpPr txBox="1"/>
          <p:nvPr/>
        </p:nvSpPr>
        <p:spPr>
          <a:xfrm>
            <a:off x="58886" y="3530764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cs typeface="Arial" panose="020B0604020202020204" pitchFamily="34" charset="0"/>
              </a:rPr>
              <a:t>F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E4F45AC7-9B55-8DD4-FA4F-93048D5B3A43}"/>
              </a:ext>
            </a:extLst>
          </p:cNvPr>
          <p:cNvSpPr txBox="1"/>
          <p:nvPr/>
        </p:nvSpPr>
        <p:spPr>
          <a:xfrm>
            <a:off x="24215" y="19853"/>
            <a:ext cx="24283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err="1"/>
              <a:t>Supplemental</a:t>
            </a:r>
            <a:r>
              <a:rPr lang="de-DE" b="1" dirty="0"/>
              <a:t> Figure S3</a:t>
            </a:r>
          </a:p>
        </p:txBody>
      </p:sp>
    </p:spTree>
    <p:extLst>
      <p:ext uri="{BB962C8B-B14F-4D97-AF65-F5344CB8AC3E}">
        <p14:creationId xmlns:p14="http://schemas.microsoft.com/office/powerpoint/2010/main" val="36219061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kt 2">
            <a:extLst>
              <a:ext uri="{FF2B5EF4-FFF2-40B4-BE49-F238E27FC236}">
                <a16:creationId xmlns:a16="http://schemas.microsoft.com/office/drawing/2014/main" id="{644397C2-39E7-1929-9B39-EB5169BBA188}"/>
              </a:ext>
            </a:extLst>
          </p:cNvPr>
          <p:cNvGraphicFramePr>
            <a:graphicFrameLocks noChangeAspect="1"/>
          </p:cNvGraphicFramePr>
          <p:nvPr/>
        </p:nvGraphicFramePr>
        <p:xfrm>
          <a:off x="520474" y="385232"/>
          <a:ext cx="9294812" cy="27670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9295100" imgH="2767385" progId="Prism10.Document">
                  <p:embed/>
                </p:oleObj>
              </mc:Choice>
              <mc:Fallback>
                <p:oleObj name="Prism 10" r:id="rId2" imgW="9295100" imgH="2767385" progId="Prism10.Document">
                  <p:embed/>
                  <p:pic>
                    <p:nvPicPr>
                      <p:cNvPr id="3" name="Objekt 2">
                        <a:extLst>
                          <a:ext uri="{FF2B5EF4-FFF2-40B4-BE49-F238E27FC236}">
                            <a16:creationId xmlns:a16="http://schemas.microsoft.com/office/drawing/2014/main" id="{644397C2-39E7-1929-9B39-EB5169BBA18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20474" y="385232"/>
                        <a:ext cx="9294812" cy="27670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kt 3">
            <a:extLst>
              <a:ext uri="{FF2B5EF4-FFF2-40B4-BE49-F238E27FC236}">
                <a16:creationId xmlns:a16="http://schemas.microsoft.com/office/drawing/2014/main" id="{FBC738F1-C126-F1B3-1C02-85DC8833BC9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4570049"/>
              </p:ext>
            </p:extLst>
          </p:nvPr>
        </p:nvGraphicFramePr>
        <p:xfrm>
          <a:off x="277629" y="3429000"/>
          <a:ext cx="11760246" cy="25267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10226301" imgH="2197206" progId="Prism10.Document">
                  <p:embed/>
                </p:oleObj>
              </mc:Choice>
              <mc:Fallback>
                <p:oleObj name="Prism 10" r:id="rId4" imgW="10226301" imgH="2197206" progId="Prism10.Document">
                  <p:embed/>
                  <p:pic>
                    <p:nvPicPr>
                      <p:cNvPr id="4" name="Objekt 3">
                        <a:extLst>
                          <a:ext uri="{FF2B5EF4-FFF2-40B4-BE49-F238E27FC236}">
                            <a16:creationId xmlns:a16="http://schemas.microsoft.com/office/drawing/2014/main" id="{FBC738F1-C126-F1B3-1C02-85DC8833BC9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77629" y="3429000"/>
                        <a:ext cx="11760246" cy="25267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feld 1">
            <a:extLst>
              <a:ext uri="{FF2B5EF4-FFF2-40B4-BE49-F238E27FC236}">
                <a16:creationId xmlns:a16="http://schemas.microsoft.com/office/drawing/2014/main" id="{EE9DB745-4C82-4A99-BCBE-4780D5E71751}"/>
              </a:ext>
            </a:extLst>
          </p:cNvPr>
          <p:cNvSpPr txBox="1"/>
          <p:nvPr/>
        </p:nvSpPr>
        <p:spPr>
          <a:xfrm>
            <a:off x="58886" y="427890"/>
            <a:ext cx="3321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cs typeface="Arial" panose="020B0604020202020204" pitchFamily="34" charset="0"/>
              </a:rPr>
              <a:t>G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2807EAA9-B39A-F5BD-3701-EA6A1EF23826}"/>
              </a:ext>
            </a:extLst>
          </p:cNvPr>
          <p:cNvSpPr txBox="1"/>
          <p:nvPr/>
        </p:nvSpPr>
        <p:spPr>
          <a:xfrm>
            <a:off x="58886" y="3461420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>
                <a:cs typeface="Arial" panose="020B0604020202020204" pitchFamily="34" charset="0"/>
              </a:rPr>
              <a:t>H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BEA4A58F-4734-2B4C-4BAE-528A27FCE417}"/>
              </a:ext>
            </a:extLst>
          </p:cNvPr>
          <p:cNvSpPr txBox="1"/>
          <p:nvPr/>
        </p:nvSpPr>
        <p:spPr>
          <a:xfrm>
            <a:off x="24215" y="19853"/>
            <a:ext cx="24283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err="1"/>
              <a:t>Supplemental</a:t>
            </a:r>
            <a:r>
              <a:rPr lang="de-DE" b="1" dirty="0"/>
              <a:t> Figure S3</a:t>
            </a:r>
          </a:p>
        </p:txBody>
      </p:sp>
    </p:spTree>
    <p:extLst>
      <p:ext uri="{BB962C8B-B14F-4D97-AF65-F5344CB8AC3E}">
        <p14:creationId xmlns:p14="http://schemas.microsoft.com/office/powerpoint/2010/main" val="10299375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</Words>
  <Application>Microsoft Office PowerPoint</Application>
  <PresentationFormat>Breitbild</PresentationFormat>
  <Paragraphs>12</Paragraphs>
  <Slides>4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Office</vt:lpstr>
      <vt:lpstr>Prism 10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 B</dc:creator>
  <cp:lastModifiedBy>M B</cp:lastModifiedBy>
  <cp:revision>34</cp:revision>
  <dcterms:created xsi:type="dcterms:W3CDTF">2024-02-02T14:39:04Z</dcterms:created>
  <dcterms:modified xsi:type="dcterms:W3CDTF">2024-03-24T19:45:18Z</dcterms:modified>
</cp:coreProperties>
</file>